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 autoCompressPictures="0">
  <p:sldMasterIdLst>
    <p:sldMasterId id="2147483648" r:id="rId1"/>
  </p:sldMasterIdLst>
  <p:sldIdLst>
    <p:sldId id="263" r:id="rId2"/>
    <p:sldId id="264" r:id="rId3"/>
    <p:sldId id="265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2" name="Author" initials="A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8034E78-7F5D-4C2E-B375-FC64B27BC917}" styleName="Dark Style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956" autoAdjust="0"/>
    <p:restoredTop sz="94674"/>
  </p:normalViewPr>
  <p:slideViewPr>
    <p:cSldViewPr snapToGrid="0" snapToObjects="1">
      <p:cViewPr varScale="1">
        <p:scale>
          <a:sx n="95" d="100"/>
          <a:sy n="95" d="100"/>
        </p:scale>
        <p:origin x="114" y="5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07DECF-C497-EB4B-8862-FC803FDAD2E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C4A428D-5515-4948-B9EA-1C73D2E0FC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F74F09-2D7C-F24A-B09C-807743019D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7A3F8-6AF9-8D40-81AE-C0F45554E4D4}" type="datetimeFigureOut">
              <a:rPr lang="en-US" smtClean="0"/>
              <a:t>3/12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9A0F48-0678-B048-BFB7-15C1FA9E37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019F66-3AB5-E14C-AA07-156B23A3EE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FB029-38A7-AB45-BD9B-1E38FD509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1011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789C56-988E-D14C-9000-D244340F1E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26AFEB3-1004-C243-8EDF-8F05D0F864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B37740-DAE0-5749-BB1E-B9015649BF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7A3F8-6AF9-8D40-81AE-C0F45554E4D4}" type="datetimeFigureOut">
              <a:rPr lang="en-US" smtClean="0"/>
              <a:t>3/12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E82595-D9D6-1A4C-931F-FDE7228EF7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34A5D3-3E18-1B49-A093-00B08A3231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FB029-38A7-AB45-BD9B-1E38FD509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485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1C85753-8D4E-CB49-B942-68CA9EE6D7F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A57EB55-BB6F-5C44-833C-FECCA61654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43CACF-A98E-E94D-90EA-AF2C5E8899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7A3F8-6AF9-8D40-81AE-C0F45554E4D4}" type="datetimeFigureOut">
              <a:rPr lang="en-US" smtClean="0"/>
              <a:t>3/12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CBB0FC-C684-374A-A678-2BB4FC5278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37CFD4-5670-D74F-BA6E-0C10C7C7CC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FB029-38A7-AB45-BD9B-1E38FD509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61566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049D1B-D1C0-BF45-B01D-CC8EBB1BC2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BC04AC-4DB0-6448-8475-5A45D49C040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2410E3-CB21-2D43-AF42-E136889C5E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7A3F8-6AF9-8D40-81AE-C0F45554E4D4}" type="datetimeFigureOut">
              <a:rPr lang="en-US" smtClean="0"/>
              <a:t>3/12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0861B3-7988-AF4D-BC20-E51F4869B5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9FEEE6-6D53-C843-AC5A-BC1534B448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FB029-38A7-AB45-BD9B-1E38FD509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53555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78A669-71E3-5647-BBD6-5B00E10AF1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084BB2-FC25-F146-A542-79F71FAFD8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CD747B-D521-7545-9A30-17D87162FD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7A3F8-6AF9-8D40-81AE-C0F45554E4D4}" type="datetimeFigureOut">
              <a:rPr lang="en-US" smtClean="0"/>
              <a:t>3/12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A8E6FB-33F0-5246-86F9-1A465939C3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1BEDD2-5D35-4644-ADE0-9144DC4510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FB029-38A7-AB45-BD9B-1E38FD509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67715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B9F4FB-0C44-8B44-97C0-B1270BCE5F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5EAB37-B77D-3B40-B595-7C960125078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4A5DD66-946B-4C4C-B59B-15946AC63DE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42D388F-8FD0-FE45-8E35-CFC1212A99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7A3F8-6AF9-8D40-81AE-C0F45554E4D4}" type="datetimeFigureOut">
              <a:rPr lang="en-US" smtClean="0"/>
              <a:t>3/12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520C61-6D3A-484C-AADC-039BEF2198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98D62EB-B84F-C743-8E55-CB9D2D5537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FB029-38A7-AB45-BD9B-1E38FD509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35309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83E0D9-C27E-8449-B6D0-DCB34437F7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B5D0C5-504F-E841-A637-E45FCEE384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0B4C955-91CE-8843-816C-E26D35675C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D09D36C-8348-FD46-B894-71651E81CF5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A007646-D2C1-164A-9F30-43194A9FE30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C7050D0-765B-B545-9B69-39754BE5C1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7A3F8-6AF9-8D40-81AE-C0F45554E4D4}" type="datetimeFigureOut">
              <a:rPr lang="en-US" smtClean="0"/>
              <a:t>3/12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906B964-3F10-0846-B697-53C28173E8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19AA8D4-0368-2F4C-A5E2-0586BEAE9B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FB029-38A7-AB45-BD9B-1E38FD509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0951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15E8B0-8191-3746-AEC2-9F262DFD39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E45B831-C9DE-3C49-B251-D6C5E53611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7A3F8-6AF9-8D40-81AE-C0F45554E4D4}" type="datetimeFigureOut">
              <a:rPr lang="en-US" smtClean="0"/>
              <a:t>3/12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1E3D83B-AC07-F948-BC72-60B517B67D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7791429-906D-3F42-AD66-703081D0CE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FB029-38A7-AB45-BD9B-1E38FD509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7654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D903DD8-0011-0E49-AFFE-F52302E3ED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7A3F8-6AF9-8D40-81AE-C0F45554E4D4}" type="datetimeFigureOut">
              <a:rPr lang="en-US" smtClean="0"/>
              <a:t>3/12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6B4BC36-AAC2-0542-86B6-9077ABD5EE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DCB610C-13AB-CC48-A2E9-BE0962A46C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FB029-38A7-AB45-BD9B-1E38FD509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74586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9597E6-8697-D84C-BC80-3AB1ED3488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2B14B1-FB46-C846-8506-2127E5E30C7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8E7ECED-D407-C747-874F-CC30D30506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56AD547-B417-CA4B-A3A3-2CC0DFE12B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7A3F8-6AF9-8D40-81AE-C0F45554E4D4}" type="datetimeFigureOut">
              <a:rPr lang="en-US" smtClean="0"/>
              <a:t>3/12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CAA59A-C3A9-814B-8ABA-18E49AC11C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232631-555B-EE47-83B2-50D3DC4881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FB029-38A7-AB45-BD9B-1E38FD509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83192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AE3E73-75B7-D940-BDF4-2A52CE4FAD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805AB34-2155-7B4A-8A4D-27434DBC9B8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343ED2-6A53-CB4F-A74C-1186CB2B9B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60B542A-46F4-E94D-935D-C8B7222760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7A3F8-6AF9-8D40-81AE-C0F45554E4D4}" type="datetimeFigureOut">
              <a:rPr lang="en-US" smtClean="0"/>
              <a:t>3/12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6C768B2-D4C5-3A4D-92CC-D4994F5CDD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1D0008F-E5B5-E749-8ED2-CDCADC22AD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FB029-38A7-AB45-BD9B-1E38FD509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38890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BF4D96A-411B-2D44-AAEF-8D7C9BD84C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DD9B6E-5BBF-1D45-AFA8-2C37625434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29EEC7-DE60-4D46-812B-FFCD485807F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67A3F8-6AF9-8D40-81AE-C0F45554E4D4}" type="datetimeFigureOut">
              <a:rPr lang="en-US" smtClean="0"/>
              <a:t>3/12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51BCE4-84C2-4842-84B2-479E566C499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B13340-25A4-BC49-847D-46B78278BEF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8FB029-38A7-AB45-BD9B-1E38FD509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27948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F85F67EB-2106-5440-A26C-5C0AB49CC53D}"/>
              </a:ext>
            </a:extLst>
          </p:cNvPr>
          <p:cNvSpPr/>
          <p:nvPr/>
        </p:nvSpPr>
        <p:spPr>
          <a:xfrm>
            <a:off x="304799" y="1757419"/>
            <a:ext cx="11642362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AU" b="1" dirty="0">
                <a:latin typeface="Calibri" panose="020F0502020204030204" pitchFamily="34" charset="0"/>
                <a:ea typeface="Times New Roman" panose="02020603050405020304" pitchFamily="18" charset="0"/>
              </a:rPr>
              <a:t>Additional file 3: Figure S1.</a:t>
            </a:r>
            <a:r>
              <a:rPr lang="en-AU" dirty="0"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</a:p>
          <a:p>
            <a:pPr algn="just"/>
            <a:endParaRPr lang="en-AU" dirty="0">
              <a:latin typeface="Calibri" panose="020F0502020204030204" pitchFamily="34" charset="0"/>
              <a:ea typeface="Times New Roman" panose="02020603050405020304" pitchFamily="18" charset="0"/>
            </a:endParaRPr>
          </a:p>
          <a:p>
            <a:pPr algn="just"/>
            <a:r>
              <a:rPr lang="en-AU" dirty="0">
                <a:latin typeface="Calibri" panose="020F0502020204030204" pitchFamily="34" charset="0"/>
                <a:ea typeface="Times New Roman" panose="02020603050405020304" pitchFamily="18" charset="0"/>
              </a:rPr>
              <a:t>Response variables for all haplotypes, Clade ‘Sydney’, Clade ‘Darwin’ and Clade ‘Cairns’ respectively. The model bioclimatic response variables accounted for temperatures greater than 3°C and less than 35°C with precipitation levels lower than 2000mm which are all within the abiotic requirements for flea development and survival (Silverman &amp; Rust, 1983 [17]; Dryden, 1989 [18]). </a:t>
            </a:r>
            <a:endParaRPr lang="en-AU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589950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701BEA1-FB63-4687-B32E-2B0AF4F225C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4229"/>
          <a:stretch/>
        </p:blipFill>
        <p:spPr>
          <a:xfrm>
            <a:off x="1097555" y="1620252"/>
            <a:ext cx="4572000" cy="3921431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9F35D8A-8611-4C11-9413-C486C393DB2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4229"/>
          <a:stretch/>
        </p:blipFill>
        <p:spPr>
          <a:xfrm>
            <a:off x="6522445" y="1620252"/>
            <a:ext cx="4572000" cy="392143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B089372-FF98-4A71-A80F-211D75C7EBD1}"/>
              </a:ext>
            </a:extLst>
          </p:cNvPr>
          <p:cNvSpPr txBox="1"/>
          <p:nvPr/>
        </p:nvSpPr>
        <p:spPr>
          <a:xfrm>
            <a:off x="1097555" y="985018"/>
            <a:ext cx="46291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Response curves for </a:t>
            </a:r>
            <a:r>
              <a:rPr lang="en-AU" b="1" i="1" dirty="0"/>
              <a:t>Ctenocephalides </a:t>
            </a:r>
            <a:r>
              <a:rPr lang="en-AU" b="1" i="1" dirty="0" err="1"/>
              <a:t>felis</a:t>
            </a:r>
            <a:r>
              <a:rPr lang="en-AU" b="1" i="1" dirty="0"/>
              <a:t> </a:t>
            </a:r>
            <a:r>
              <a:rPr lang="en-AU" b="1" dirty="0"/>
              <a:t>“all”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23410C3-CF19-4AEC-A464-0207B4C62A24}"/>
              </a:ext>
            </a:extLst>
          </p:cNvPr>
          <p:cNvSpPr txBox="1"/>
          <p:nvPr/>
        </p:nvSpPr>
        <p:spPr>
          <a:xfrm>
            <a:off x="6493869" y="968794"/>
            <a:ext cx="50983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Response curves for </a:t>
            </a:r>
            <a:r>
              <a:rPr lang="en-AU" b="1" i="1" dirty="0"/>
              <a:t>Ctenocephalides </a:t>
            </a:r>
            <a:r>
              <a:rPr lang="en-AU" b="1" i="1" dirty="0" err="1"/>
              <a:t>felis</a:t>
            </a:r>
            <a:r>
              <a:rPr lang="en-AU" b="1" i="1" dirty="0"/>
              <a:t> </a:t>
            </a:r>
            <a:r>
              <a:rPr lang="en-AU" b="1" dirty="0"/>
              <a:t>“Sydney”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C1CEA29-B5C5-42B5-A014-B5BF027C28B5}"/>
              </a:ext>
            </a:extLst>
          </p:cNvPr>
          <p:cNvSpPr txBox="1"/>
          <p:nvPr/>
        </p:nvSpPr>
        <p:spPr>
          <a:xfrm rot="16200000">
            <a:off x="523950" y="4478697"/>
            <a:ext cx="7697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b="1" dirty="0"/>
              <a:t>probability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0B836CD-4408-48E1-AFF3-086302CA3356}"/>
              </a:ext>
            </a:extLst>
          </p:cNvPr>
          <p:cNvSpPr txBox="1"/>
          <p:nvPr/>
        </p:nvSpPr>
        <p:spPr>
          <a:xfrm rot="16200000">
            <a:off x="528008" y="2426213"/>
            <a:ext cx="7697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b="1" dirty="0"/>
              <a:t>probability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978B9EB9-681D-4A85-86A0-2D0E610B1506}"/>
              </a:ext>
            </a:extLst>
          </p:cNvPr>
          <p:cNvSpPr/>
          <p:nvPr/>
        </p:nvSpPr>
        <p:spPr>
          <a:xfrm>
            <a:off x="1170812" y="1625578"/>
            <a:ext cx="2241319" cy="246221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AU" sz="1000" b="1" dirty="0"/>
              <a:t>B16 = Precipitation of Wettest Quarter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CBB82C86-511A-472A-8C3C-1135234B64F3}"/>
              </a:ext>
            </a:extLst>
          </p:cNvPr>
          <p:cNvSpPr/>
          <p:nvPr/>
        </p:nvSpPr>
        <p:spPr>
          <a:xfrm>
            <a:off x="3383555" y="1625577"/>
            <a:ext cx="2451312" cy="246221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AU" sz="1000" b="1" dirty="0"/>
              <a:t>B5 = Max Temperature of Warmest Month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BFE96B99-3335-429A-9C33-B2E938C32DD6}"/>
              </a:ext>
            </a:extLst>
          </p:cNvPr>
          <p:cNvSpPr/>
          <p:nvPr/>
        </p:nvSpPr>
        <p:spPr>
          <a:xfrm>
            <a:off x="1141957" y="3607482"/>
            <a:ext cx="2299027" cy="246221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AU" sz="1000" b="1" dirty="0"/>
              <a:t>B18 = Precipitation of Warmest Quarter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21C0EE15-F465-4768-B0D1-2A1CFB3EBFD1}"/>
              </a:ext>
            </a:extLst>
          </p:cNvPr>
          <p:cNvSpPr/>
          <p:nvPr/>
        </p:nvSpPr>
        <p:spPr>
          <a:xfrm>
            <a:off x="3383555" y="3612703"/>
            <a:ext cx="2553904" cy="246221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AU" sz="1000" b="1" dirty="0"/>
              <a:t>B11 = Mean Temperature of Coldest Quarter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4E43A56-EAA0-4880-920A-7B0CA342D494}"/>
              </a:ext>
            </a:extLst>
          </p:cNvPr>
          <p:cNvSpPr txBox="1"/>
          <p:nvPr/>
        </p:nvSpPr>
        <p:spPr>
          <a:xfrm rot="16200000">
            <a:off x="5992772" y="4478697"/>
            <a:ext cx="7697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b="1" dirty="0"/>
              <a:t>probability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FB0A56C-F9AC-43FC-A37F-EF3B46823232}"/>
              </a:ext>
            </a:extLst>
          </p:cNvPr>
          <p:cNvSpPr txBox="1"/>
          <p:nvPr/>
        </p:nvSpPr>
        <p:spPr>
          <a:xfrm rot="16200000">
            <a:off x="5996830" y="2426213"/>
            <a:ext cx="7697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b="1" dirty="0"/>
              <a:t>probability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2DEF8AE4-A8DC-4F0E-B644-A4A44AE31E16}"/>
              </a:ext>
            </a:extLst>
          </p:cNvPr>
          <p:cNvSpPr/>
          <p:nvPr/>
        </p:nvSpPr>
        <p:spPr>
          <a:xfrm>
            <a:off x="6639634" y="1625578"/>
            <a:ext cx="2241319" cy="246221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AU" sz="1000" b="1" dirty="0"/>
              <a:t>B16 = Precipitation of Wettest Quarter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3159F9D0-4152-4236-A89A-0EDFFB955353}"/>
              </a:ext>
            </a:extLst>
          </p:cNvPr>
          <p:cNvSpPr/>
          <p:nvPr/>
        </p:nvSpPr>
        <p:spPr>
          <a:xfrm>
            <a:off x="8852377" y="1625577"/>
            <a:ext cx="2451312" cy="246221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AU" sz="1000" b="1" dirty="0"/>
              <a:t>B5 = Max Temperature of Warmest Month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53186857-382A-4579-A040-949B9FCD48E4}"/>
              </a:ext>
            </a:extLst>
          </p:cNvPr>
          <p:cNvSpPr/>
          <p:nvPr/>
        </p:nvSpPr>
        <p:spPr>
          <a:xfrm>
            <a:off x="6610779" y="3607482"/>
            <a:ext cx="2299027" cy="246221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AU" sz="1000" b="1" dirty="0"/>
              <a:t>B18 = Precipitation of Warmest Quarter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579AF158-6D9A-441A-AB7A-8B289357EF94}"/>
              </a:ext>
            </a:extLst>
          </p:cNvPr>
          <p:cNvSpPr/>
          <p:nvPr/>
        </p:nvSpPr>
        <p:spPr>
          <a:xfrm>
            <a:off x="8852377" y="3612703"/>
            <a:ext cx="2553904" cy="246221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AU" sz="1000" b="1" dirty="0"/>
              <a:t>B11 = Mean Temperature of Coldest Quarter</a:t>
            </a:r>
          </a:p>
        </p:txBody>
      </p:sp>
    </p:spTree>
    <p:extLst>
      <p:ext uri="{BB962C8B-B14F-4D97-AF65-F5344CB8AC3E}">
        <p14:creationId xmlns:p14="http://schemas.microsoft.com/office/powerpoint/2010/main" val="36822631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B350C913-03E7-4467-AA95-CF6FE66718D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3947"/>
          <a:stretch/>
        </p:blipFill>
        <p:spPr>
          <a:xfrm>
            <a:off x="1352388" y="1780674"/>
            <a:ext cx="4572000" cy="393432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CF0DA9D5-0B35-49C3-9442-0BEAE1CABE2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3947"/>
          <a:stretch/>
        </p:blipFill>
        <p:spPr>
          <a:xfrm>
            <a:off x="6627378" y="1780674"/>
            <a:ext cx="4572000" cy="393432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8A19E99-FE0D-4CCE-8E9D-783A404A8616}"/>
              </a:ext>
            </a:extLst>
          </p:cNvPr>
          <p:cNvSpPr txBox="1"/>
          <p:nvPr/>
        </p:nvSpPr>
        <p:spPr>
          <a:xfrm>
            <a:off x="1097555" y="985018"/>
            <a:ext cx="51035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Response curves for </a:t>
            </a:r>
            <a:r>
              <a:rPr lang="en-AU" b="1" i="1" dirty="0"/>
              <a:t>Ctenocephalides </a:t>
            </a:r>
            <a:r>
              <a:rPr lang="en-AU" b="1" i="1" dirty="0" err="1"/>
              <a:t>felis</a:t>
            </a:r>
            <a:r>
              <a:rPr lang="en-AU" b="1" i="1" dirty="0"/>
              <a:t> </a:t>
            </a:r>
            <a:r>
              <a:rPr lang="en-AU" b="1" dirty="0"/>
              <a:t>“Darwin”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F7D1966-BD6F-4587-A227-3CD514AAAD92}"/>
              </a:ext>
            </a:extLst>
          </p:cNvPr>
          <p:cNvSpPr txBox="1"/>
          <p:nvPr/>
        </p:nvSpPr>
        <p:spPr>
          <a:xfrm>
            <a:off x="6493869" y="982442"/>
            <a:ext cx="49979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Response curves for </a:t>
            </a:r>
            <a:r>
              <a:rPr lang="en-AU" b="1" i="1" dirty="0"/>
              <a:t>Ctenocephalides </a:t>
            </a:r>
            <a:r>
              <a:rPr lang="en-AU" b="1" i="1" dirty="0" err="1"/>
              <a:t>felis</a:t>
            </a:r>
            <a:r>
              <a:rPr lang="en-AU" b="1" i="1" dirty="0"/>
              <a:t> </a:t>
            </a:r>
            <a:r>
              <a:rPr lang="en-AU" b="1" dirty="0"/>
              <a:t>“Cairns”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FB63BBD-5EE8-454A-ACD1-5FD1201A41AE}"/>
              </a:ext>
            </a:extLst>
          </p:cNvPr>
          <p:cNvSpPr txBox="1"/>
          <p:nvPr/>
        </p:nvSpPr>
        <p:spPr>
          <a:xfrm rot="16200000">
            <a:off x="734381" y="4620676"/>
            <a:ext cx="7697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b="1" dirty="0"/>
              <a:t>probability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566CD25-F517-4028-8CB7-FA92E70D0E00}"/>
              </a:ext>
            </a:extLst>
          </p:cNvPr>
          <p:cNvSpPr txBox="1"/>
          <p:nvPr/>
        </p:nvSpPr>
        <p:spPr>
          <a:xfrm rot="16200000">
            <a:off x="738439" y="2568192"/>
            <a:ext cx="7697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b="1" dirty="0"/>
              <a:t>probability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36BA48DA-B516-4849-A04B-9A6BB6AAF7E3}"/>
              </a:ext>
            </a:extLst>
          </p:cNvPr>
          <p:cNvSpPr/>
          <p:nvPr/>
        </p:nvSpPr>
        <p:spPr>
          <a:xfrm>
            <a:off x="1381243" y="1767557"/>
            <a:ext cx="2241319" cy="246221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AU" sz="1000" b="1" dirty="0"/>
              <a:t>B16 = Precipitation of Wettest Quarter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BFCC6C19-B5F8-4A03-B330-83FA418AB11A}"/>
              </a:ext>
            </a:extLst>
          </p:cNvPr>
          <p:cNvSpPr/>
          <p:nvPr/>
        </p:nvSpPr>
        <p:spPr>
          <a:xfrm>
            <a:off x="3593986" y="1767556"/>
            <a:ext cx="2451312" cy="246221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AU" sz="1000" b="1" dirty="0"/>
              <a:t>B5 = Max Temperature of Warmest Month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E5847C1C-89B4-43B1-B911-BD05A1C37C4E}"/>
              </a:ext>
            </a:extLst>
          </p:cNvPr>
          <p:cNvSpPr/>
          <p:nvPr/>
        </p:nvSpPr>
        <p:spPr>
          <a:xfrm>
            <a:off x="1352388" y="3749461"/>
            <a:ext cx="2299027" cy="246221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AU" sz="1000" b="1" dirty="0"/>
              <a:t>B18 = Precipitation of Warmest Quarter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F0B69E15-67D7-49FC-93A1-EBFB9BCA1E9F}"/>
              </a:ext>
            </a:extLst>
          </p:cNvPr>
          <p:cNvSpPr/>
          <p:nvPr/>
        </p:nvSpPr>
        <p:spPr>
          <a:xfrm>
            <a:off x="3593986" y="3754682"/>
            <a:ext cx="2553904" cy="246221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AU" sz="1000" b="1" dirty="0"/>
              <a:t>B11 = Mean Temperature of Coldest Quarter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CEB7AFC-A8CE-4AE6-B57C-9A6449FA4A27}"/>
              </a:ext>
            </a:extLst>
          </p:cNvPr>
          <p:cNvSpPr txBox="1"/>
          <p:nvPr/>
        </p:nvSpPr>
        <p:spPr>
          <a:xfrm rot="16200000">
            <a:off x="5980516" y="4601806"/>
            <a:ext cx="7697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b="1" dirty="0"/>
              <a:t>probability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C89A8C4-E554-4E70-A2BF-B4552F8BC792}"/>
              </a:ext>
            </a:extLst>
          </p:cNvPr>
          <p:cNvSpPr txBox="1"/>
          <p:nvPr/>
        </p:nvSpPr>
        <p:spPr>
          <a:xfrm rot="16200000">
            <a:off x="5984574" y="2549322"/>
            <a:ext cx="7697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b="1" dirty="0"/>
              <a:t>probability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E6E4A526-9511-47DC-9947-ED130F629457}"/>
              </a:ext>
            </a:extLst>
          </p:cNvPr>
          <p:cNvSpPr/>
          <p:nvPr/>
        </p:nvSpPr>
        <p:spPr>
          <a:xfrm>
            <a:off x="6627378" y="1748687"/>
            <a:ext cx="2241319" cy="246221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AU" sz="1000" b="1" dirty="0"/>
              <a:t>B16 = Precipitation of Wettest Quarter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E994D6E5-26E2-4A62-AC85-4BADA2F3FF2E}"/>
              </a:ext>
            </a:extLst>
          </p:cNvPr>
          <p:cNvSpPr/>
          <p:nvPr/>
        </p:nvSpPr>
        <p:spPr>
          <a:xfrm>
            <a:off x="8840121" y="1748686"/>
            <a:ext cx="2451312" cy="246221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AU" sz="1000" b="1" dirty="0"/>
              <a:t>B5 = Max Temperature of Warmest Month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DADB3B0A-5BEE-410D-8308-6264219DC00C}"/>
              </a:ext>
            </a:extLst>
          </p:cNvPr>
          <p:cNvSpPr/>
          <p:nvPr/>
        </p:nvSpPr>
        <p:spPr>
          <a:xfrm>
            <a:off x="6598523" y="3730591"/>
            <a:ext cx="2299027" cy="246221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AU" sz="1000" b="1" dirty="0"/>
              <a:t>B18 = Precipitation of Warmest Quarter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D6A3A933-D336-4956-B4E7-8796373BD521}"/>
              </a:ext>
            </a:extLst>
          </p:cNvPr>
          <p:cNvSpPr/>
          <p:nvPr/>
        </p:nvSpPr>
        <p:spPr>
          <a:xfrm>
            <a:off x="8840121" y="3735812"/>
            <a:ext cx="2553904" cy="246221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AU" sz="1000" b="1" dirty="0"/>
              <a:t>B11 = Mean Temperature of Coldest Quarter</a:t>
            </a:r>
          </a:p>
        </p:txBody>
      </p:sp>
    </p:spTree>
    <p:extLst>
      <p:ext uri="{BB962C8B-B14F-4D97-AF65-F5344CB8AC3E}">
        <p14:creationId xmlns:p14="http://schemas.microsoft.com/office/powerpoint/2010/main" val="8778328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4</Words>
  <Application>Microsoft Office PowerPoint</Application>
  <PresentationFormat>Widescreen</PresentationFormat>
  <Paragraphs>3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/>
  <cp:revision>16</cp:revision>
  <dcterms:created xsi:type="dcterms:W3CDTF">2018-11-07T02:29:48Z</dcterms:created>
  <dcterms:modified xsi:type="dcterms:W3CDTF">2019-03-12T12:08:00Z</dcterms:modified>
</cp:coreProperties>
</file>